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4" r:id="rId2"/>
    <p:sldId id="267" r:id="rId3"/>
    <p:sldId id="257" r:id="rId4"/>
    <p:sldId id="265" r:id="rId5"/>
    <p:sldId id="266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7" userDrawn="1">
          <p15:clr>
            <a:srgbClr val="A4A3A4"/>
          </p15:clr>
        </p15:guide>
        <p15:guide id="2" orient="horz" pos="3884" userDrawn="1">
          <p15:clr>
            <a:srgbClr val="A4A3A4"/>
          </p15:clr>
        </p15:guide>
        <p15:guide id="3" pos="2925" userDrawn="1">
          <p15:clr>
            <a:srgbClr val="A4A3A4"/>
          </p15:clr>
        </p15:guide>
        <p15:guide id="4" pos="11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harma" initials="P" lastIdx="2" clrIdx="0">
    <p:extLst>
      <p:ext uri="{19B8F6BF-5375-455C-9EA6-DF929625EA0E}">
        <p15:presenceInfo xmlns:p15="http://schemas.microsoft.com/office/powerpoint/2012/main" userId="Pharma" providerId="None"/>
      </p:ext>
    </p:extLst>
  </p:cmAuthor>
  <p:cmAuthor id="2" name="Microsoft-Konto" initials="M" lastIdx="22" clrIdx="1">
    <p:extLst>
      <p:ext uri="{19B8F6BF-5375-455C-9EA6-DF929625EA0E}">
        <p15:presenceInfo xmlns:p15="http://schemas.microsoft.com/office/powerpoint/2012/main" userId="bbebdfcae4d7f382" providerId="Windows Live"/>
      </p:ext>
    </p:extLst>
  </p:cmAuthor>
  <p:cmAuthor id="3" name="Torsten Christ" initials="TC" lastIdx="9" clrIdx="2">
    <p:extLst>
      <p:ext uri="{19B8F6BF-5375-455C-9EA6-DF929625EA0E}">
        <p15:presenceInfo xmlns:p15="http://schemas.microsoft.com/office/powerpoint/2012/main" userId="319a7b1db1437c3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218" autoAdjust="0"/>
    <p:restoredTop sz="91810" autoAdjust="0"/>
  </p:normalViewPr>
  <p:slideViewPr>
    <p:cSldViewPr snapToGrid="0">
      <p:cViewPr varScale="1">
        <p:scale>
          <a:sx n="106" d="100"/>
          <a:sy n="106" d="100"/>
        </p:scale>
        <p:origin x="1416" y="176"/>
      </p:cViewPr>
      <p:guideLst>
        <p:guide orient="horz" pos="187"/>
        <p:guide orient="horz" pos="3884"/>
        <p:guide pos="2925"/>
        <p:guide pos="11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738E6C-83AF-4B20-ACF8-CF74F3C52BB1}" type="datetimeFigureOut">
              <a:rPr lang="en-US" smtClean="0"/>
              <a:t>8/29/25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6F6FA1-6B79-426B-AE1B-B9662DB30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657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7"/>
            <a:ext cx="6858000" cy="165576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804C3-BC97-4D4E-B04F-DDE6735C7FFC}" type="datetimeFigureOut">
              <a:rPr lang="en-US" smtClean="0"/>
              <a:t>8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4D578-9F79-4BC7-9BC6-99185CA516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0431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804C3-BC97-4D4E-B04F-DDE6735C7FFC}" type="datetimeFigureOut">
              <a:rPr lang="en-US" smtClean="0"/>
              <a:t>8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4D578-9F79-4BC7-9BC6-99185CA516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155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9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2" y="365126"/>
            <a:ext cx="5800725" cy="5811839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804C3-BC97-4D4E-B04F-DDE6735C7FFC}" type="datetimeFigureOut">
              <a:rPr lang="en-US" smtClean="0"/>
              <a:t>8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4D578-9F79-4BC7-9BC6-99185CA516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301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804C3-BC97-4D4E-B04F-DDE6735C7FFC}" type="datetimeFigureOut">
              <a:rPr lang="en-US" smtClean="0"/>
              <a:t>8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4D578-9F79-4BC7-9BC6-99185CA516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425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804C3-BC97-4D4E-B04F-DDE6735C7FFC}" type="datetimeFigureOut">
              <a:rPr lang="en-US" smtClean="0"/>
              <a:t>8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4D578-9F79-4BC7-9BC6-99185CA516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611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804C3-BC97-4D4E-B04F-DDE6735C7FFC}" type="datetimeFigureOut">
              <a:rPr lang="en-US" smtClean="0"/>
              <a:t>8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4D578-9F79-4BC7-9BC6-99185CA516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363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7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2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2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804C3-BC97-4D4E-B04F-DDE6735C7FFC}" type="datetimeFigureOut">
              <a:rPr lang="en-US" smtClean="0"/>
              <a:t>8/2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4D578-9F79-4BC7-9BC6-99185CA516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374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804C3-BC97-4D4E-B04F-DDE6735C7FFC}" type="datetimeFigureOut">
              <a:rPr lang="en-US" smtClean="0"/>
              <a:t>8/2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4D578-9F79-4BC7-9BC6-99185CA516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971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804C3-BC97-4D4E-B04F-DDE6735C7FFC}" type="datetimeFigureOut">
              <a:rPr lang="en-US" smtClean="0"/>
              <a:t>8/2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4D578-9F79-4BC7-9BC6-99185CA516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131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1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804C3-BC97-4D4E-B04F-DDE6735C7FFC}" type="datetimeFigureOut">
              <a:rPr lang="en-US" smtClean="0"/>
              <a:t>8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4D578-9F79-4BC7-9BC6-99185CA516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70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1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804C3-BC97-4D4E-B04F-DDE6735C7FFC}" type="datetimeFigureOut">
              <a:rPr lang="en-US" smtClean="0"/>
              <a:t>8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4D578-9F79-4BC7-9BC6-99185CA516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471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B804C3-BC97-4D4E-B04F-DDE6735C7FFC}" type="datetimeFigureOut">
              <a:rPr lang="en-US" smtClean="0"/>
              <a:t>8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24D578-9F79-4BC7-9BC6-99185CA516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856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8121BC3F-9B0B-42C9-BE36-3139CF54C2E1}"/>
              </a:ext>
            </a:extLst>
          </p:cNvPr>
          <p:cNvSpPr txBox="1"/>
          <p:nvPr/>
        </p:nvSpPr>
        <p:spPr>
          <a:xfrm>
            <a:off x="8356040" y="6581001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1697" y="1862807"/>
            <a:ext cx="5160605" cy="31323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45558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/>
          <a:srcRect t="9715"/>
          <a:stretch/>
        </p:blipFill>
        <p:spPr>
          <a:xfrm>
            <a:off x="111258" y="3805883"/>
            <a:ext cx="3665744" cy="3163333"/>
          </a:xfrm>
          <a:prstGeom prst="rect">
            <a:avLst/>
          </a:prstGeom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id="{9500BB06-AA70-4A89-BD41-990F47344A97}"/>
              </a:ext>
            </a:extLst>
          </p:cNvPr>
          <p:cNvSpPr txBox="1"/>
          <p:nvPr/>
        </p:nvSpPr>
        <p:spPr>
          <a:xfrm>
            <a:off x="1252926" y="0"/>
            <a:ext cx="18117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PSC-</a:t>
            </a:r>
            <a:r>
              <a:rPr lang="en-US" sz="2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M</a:t>
            </a:r>
            <a:endParaRPr lang="en-US" sz="2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8121BC3F-9B0B-42C9-BE36-3139CF54C2E1}"/>
              </a:ext>
            </a:extLst>
          </p:cNvPr>
          <p:cNvSpPr txBox="1"/>
          <p:nvPr/>
        </p:nvSpPr>
        <p:spPr>
          <a:xfrm>
            <a:off x="6074279" y="0"/>
            <a:ext cx="17940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iPSC-</a:t>
            </a:r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vCM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8121BC3F-9B0B-42C9-BE36-3139CF54C2E1}"/>
              </a:ext>
            </a:extLst>
          </p:cNvPr>
          <p:cNvSpPr txBox="1"/>
          <p:nvPr/>
        </p:nvSpPr>
        <p:spPr>
          <a:xfrm>
            <a:off x="8356040" y="6581001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3"/>
          <a:srcRect l="10327" t="9150"/>
          <a:stretch/>
        </p:blipFill>
        <p:spPr>
          <a:xfrm>
            <a:off x="5422902" y="3822700"/>
            <a:ext cx="3329875" cy="3200400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4"/>
          <a:srcRect l="9646"/>
          <a:stretch/>
        </p:blipFill>
        <p:spPr>
          <a:xfrm>
            <a:off x="5404022" y="392418"/>
            <a:ext cx="3355159" cy="3532264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0" y="769108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  <a:endParaRPr lang="en-US" dirty="0"/>
          </a:p>
        </p:txBody>
      </p:sp>
      <p:sp>
        <p:nvSpPr>
          <p:cNvPr id="10" name="Textfeld 9"/>
          <p:cNvSpPr txBox="1"/>
          <p:nvPr/>
        </p:nvSpPr>
        <p:spPr>
          <a:xfrm>
            <a:off x="0" y="386983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  <a:endParaRPr lang="en-US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1258" y="350857"/>
            <a:ext cx="3665744" cy="35037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90195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feld 14">
            <a:extLst>
              <a:ext uri="{FF2B5EF4-FFF2-40B4-BE49-F238E27FC236}">
                <a16:creationId xmlns:a16="http://schemas.microsoft.com/office/drawing/2014/main" id="{8121BC3F-9B0B-42C9-BE36-3139CF54C2E1}"/>
              </a:ext>
            </a:extLst>
          </p:cNvPr>
          <p:cNvSpPr txBox="1"/>
          <p:nvPr/>
        </p:nvSpPr>
        <p:spPr>
          <a:xfrm>
            <a:off x="8294087" y="6581001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153749" y="502071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  <a:endParaRPr lang="en-US" dirty="0"/>
          </a:p>
        </p:txBody>
      </p:sp>
      <p:sp>
        <p:nvSpPr>
          <p:cNvPr id="14" name="Textfeld 13"/>
          <p:cNvSpPr txBox="1"/>
          <p:nvPr/>
        </p:nvSpPr>
        <p:spPr>
          <a:xfrm>
            <a:off x="153749" y="360280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  <a:endParaRPr lang="en-US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2599" y="3673731"/>
            <a:ext cx="3660781" cy="2808000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83815" y="3676297"/>
            <a:ext cx="3734923" cy="2808000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76960" y="565238"/>
            <a:ext cx="3784889" cy="2808000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69546" y="565238"/>
            <a:ext cx="3709755" cy="280800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116415" y="565239"/>
            <a:ext cx="3709755" cy="28080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-129268" y="3622125"/>
            <a:ext cx="3756840" cy="280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83587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8121BC3F-9B0B-42C9-BE36-3139CF54C2E1}"/>
              </a:ext>
            </a:extLst>
          </p:cNvPr>
          <p:cNvSpPr txBox="1"/>
          <p:nvPr/>
        </p:nvSpPr>
        <p:spPr>
          <a:xfrm>
            <a:off x="8294087" y="6581001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9500BB06-AA70-4A89-BD41-990F47344A97}"/>
              </a:ext>
            </a:extLst>
          </p:cNvPr>
          <p:cNvSpPr txBox="1"/>
          <p:nvPr/>
        </p:nvSpPr>
        <p:spPr>
          <a:xfrm>
            <a:off x="3188941" y="0"/>
            <a:ext cx="30372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rial EHT (ERC018)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/>
          <a:srcRect r="16035"/>
          <a:stretch/>
        </p:blipFill>
        <p:spPr>
          <a:xfrm>
            <a:off x="4616006" y="1923746"/>
            <a:ext cx="4277141" cy="338945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78907" y="1928484"/>
            <a:ext cx="5093955" cy="3389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13039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8121BC3F-9B0B-42C9-BE36-3139CF54C2E1}"/>
              </a:ext>
            </a:extLst>
          </p:cNvPr>
          <p:cNvSpPr txBox="1"/>
          <p:nvPr/>
        </p:nvSpPr>
        <p:spPr>
          <a:xfrm>
            <a:off x="8294087" y="6581001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9500BB06-AA70-4A89-BD41-990F47344A97}"/>
              </a:ext>
            </a:extLst>
          </p:cNvPr>
          <p:cNvSpPr txBox="1"/>
          <p:nvPr/>
        </p:nvSpPr>
        <p:spPr>
          <a:xfrm>
            <a:off x="3188941" y="0"/>
            <a:ext cx="37569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Ventricular EHT (ERC018)</a:t>
            </a: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11287" y="1918497"/>
            <a:ext cx="5255819" cy="3199031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82483" y="1743796"/>
            <a:ext cx="5217734" cy="33704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326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6</Words>
  <Application>Microsoft Macintosh PowerPoint</Application>
  <PresentationFormat>Ekran Gösterisi (4:3)</PresentationFormat>
  <Paragraphs>13</Paragraphs>
  <Slides>5</Slides>
  <Notes>0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3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 Sunusu</vt:lpstr>
      <vt:lpstr>PowerPoint Sunusu</vt:lpstr>
      <vt:lpstr>PowerPoint Sunusu</vt:lpstr>
      <vt:lpstr>PowerPoint Sunusu</vt:lpstr>
      <vt:lpstr>PowerPoint Sunusu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harma</dc:creator>
  <cp:lastModifiedBy>Muhammed Sönmez</cp:lastModifiedBy>
  <cp:revision>183</cp:revision>
  <dcterms:created xsi:type="dcterms:W3CDTF">2024-07-17T12:42:41Z</dcterms:created>
  <dcterms:modified xsi:type="dcterms:W3CDTF">2025-08-29T20:02:44Z</dcterms:modified>
</cp:coreProperties>
</file>